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9" r:id="rId3"/>
    <p:sldId id="268" r:id="rId4"/>
  </p:sldIdLst>
  <p:sldSz cx="12192000" cy="9018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奈良 克彦" initials="奈良" lastIdx="1" clrIdx="0">
    <p:extLst>
      <p:ext uri="{19B8F6BF-5375-455C-9EA6-DF929625EA0E}">
        <p15:presenceInfo xmlns:p15="http://schemas.microsoft.com/office/powerpoint/2012/main" userId="710adbbd4d7ca54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45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5959"/>
            <a:ext cx="10363200" cy="3139805"/>
          </a:xfrm>
        </p:spPr>
        <p:txBody>
          <a:bodyPr anchor="b"/>
          <a:lstStyle>
            <a:lvl1pPr algn="ctr">
              <a:defRPr sz="7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36847"/>
            <a:ext cx="9144000" cy="2177404"/>
          </a:xfrm>
        </p:spPr>
        <p:txBody>
          <a:bodyPr/>
          <a:lstStyle>
            <a:lvl1pPr marL="0" indent="0" algn="ctr">
              <a:buNone/>
              <a:defRPr sz="3156"/>
            </a:lvl1pPr>
            <a:lvl2pPr marL="601218" indent="0" algn="ctr">
              <a:buNone/>
              <a:defRPr sz="2630"/>
            </a:lvl2pPr>
            <a:lvl3pPr marL="1202436" indent="0" algn="ctr">
              <a:buNone/>
              <a:defRPr sz="2367"/>
            </a:lvl3pPr>
            <a:lvl4pPr marL="1803654" indent="0" algn="ctr">
              <a:buNone/>
              <a:defRPr sz="2104"/>
            </a:lvl4pPr>
            <a:lvl5pPr marL="2404872" indent="0" algn="ctr">
              <a:buNone/>
              <a:defRPr sz="2104"/>
            </a:lvl5pPr>
            <a:lvl6pPr marL="3006090" indent="0" algn="ctr">
              <a:buNone/>
              <a:defRPr sz="2104"/>
            </a:lvl6pPr>
            <a:lvl7pPr marL="3607308" indent="0" algn="ctr">
              <a:buNone/>
              <a:defRPr sz="2104"/>
            </a:lvl7pPr>
            <a:lvl8pPr marL="4208526" indent="0" algn="ctr">
              <a:buNone/>
              <a:defRPr sz="2104"/>
            </a:lvl8pPr>
            <a:lvl9pPr marL="4809744" indent="0" algn="ctr">
              <a:buNone/>
              <a:defRPr sz="210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655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8026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0157"/>
            <a:ext cx="2628900" cy="764283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0157"/>
            <a:ext cx="7734300" cy="764283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403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006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8387"/>
            <a:ext cx="10515600" cy="3751481"/>
          </a:xfrm>
        </p:spPr>
        <p:txBody>
          <a:bodyPr anchor="b"/>
          <a:lstStyle>
            <a:lvl1pPr>
              <a:defRPr sz="7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35359"/>
            <a:ext cx="10515600" cy="1972815"/>
          </a:xfrm>
        </p:spPr>
        <p:txBody>
          <a:bodyPr/>
          <a:lstStyle>
            <a:lvl1pPr marL="0" indent="0">
              <a:buNone/>
              <a:defRPr sz="3156">
                <a:solidFill>
                  <a:schemeClr val="tx1"/>
                </a:solidFill>
              </a:defRPr>
            </a:lvl1pPr>
            <a:lvl2pPr marL="601218" indent="0">
              <a:buNone/>
              <a:defRPr sz="2630">
                <a:solidFill>
                  <a:schemeClr val="tx1">
                    <a:tint val="75000"/>
                  </a:schemeClr>
                </a:solidFill>
              </a:defRPr>
            </a:lvl2pPr>
            <a:lvl3pPr marL="1202436" indent="0">
              <a:buNone/>
              <a:defRPr sz="2367">
                <a:solidFill>
                  <a:schemeClr val="tx1">
                    <a:tint val="75000"/>
                  </a:schemeClr>
                </a:solidFill>
              </a:defRPr>
            </a:lvl3pPr>
            <a:lvl4pPr marL="180365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4pPr>
            <a:lvl5pPr marL="2404872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5pPr>
            <a:lvl6pPr marL="3006090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6pPr>
            <a:lvl7pPr marL="3607308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7pPr>
            <a:lvl8pPr marL="4208526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8pPr>
            <a:lvl9pPr marL="480974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626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00782"/>
            <a:ext cx="5181600" cy="57222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00782"/>
            <a:ext cx="5181600" cy="57222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31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0158"/>
            <a:ext cx="10515600" cy="174317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10808"/>
            <a:ext cx="5157787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94290"/>
            <a:ext cx="5157787" cy="4845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10808"/>
            <a:ext cx="5183188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94290"/>
            <a:ext cx="5183188" cy="4845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8423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722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005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8512"/>
            <a:ext cx="6172200" cy="6409043"/>
          </a:xfrm>
        </p:spPr>
        <p:txBody>
          <a:bodyPr/>
          <a:lstStyle>
            <a:lvl1pPr>
              <a:defRPr sz="4208"/>
            </a:lvl1pPr>
            <a:lvl2pPr>
              <a:defRPr sz="3682"/>
            </a:lvl2pPr>
            <a:lvl3pPr>
              <a:defRPr sz="3156"/>
            </a:lvl3pPr>
            <a:lvl4pPr>
              <a:defRPr sz="2630"/>
            </a:lvl4pPr>
            <a:lvl5pPr>
              <a:defRPr sz="2630"/>
            </a:lvl5pPr>
            <a:lvl6pPr>
              <a:defRPr sz="2630"/>
            </a:lvl6pPr>
            <a:lvl7pPr>
              <a:defRPr sz="2630"/>
            </a:lvl7pPr>
            <a:lvl8pPr>
              <a:defRPr sz="2630"/>
            </a:lvl8pPr>
            <a:lvl9pPr>
              <a:defRPr sz="2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741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8512"/>
            <a:ext cx="6172200" cy="6409043"/>
          </a:xfrm>
        </p:spPr>
        <p:txBody>
          <a:bodyPr anchor="t"/>
          <a:lstStyle>
            <a:lvl1pPr marL="0" indent="0">
              <a:buNone/>
              <a:defRPr sz="4208"/>
            </a:lvl1pPr>
            <a:lvl2pPr marL="601218" indent="0">
              <a:buNone/>
              <a:defRPr sz="3682"/>
            </a:lvl2pPr>
            <a:lvl3pPr marL="1202436" indent="0">
              <a:buNone/>
              <a:defRPr sz="3156"/>
            </a:lvl3pPr>
            <a:lvl4pPr marL="1803654" indent="0">
              <a:buNone/>
              <a:defRPr sz="2630"/>
            </a:lvl4pPr>
            <a:lvl5pPr marL="2404872" indent="0">
              <a:buNone/>
              <a:defRPr sz="2630"/>
            </a:lvl5pPr>
            <a:lvl6pPr marL="3006090" indent="0">
              <a:buNone/>
              <a:defRPr sz="2630"/>
            </a:lvl6pPr>
            <a:lvl7pPr marL="3607308" indent="0">
              <a:buNone/>
              <a:defRPr sz="2630"/>
            </a:lvl7pPr>
            <a:lvl8pPr marL="4208526" indent="0">
              <a:buNone/>
              <a:defRPr sz="2630"/>
            </a:lvl8pPr>
            <a:lvl9pPr marL="4809744" indent="0">
              <a:buNone/>
              <a:defRPr sz="263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74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0158"/>
            <a:ext cx="10515600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00782"/>
            <a:ext cx="10515600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893F9-87C5-4D62-92A7-6C8363F678A6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58897"/>
            <a:ext cx="41148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69A89-AF2B-4417-9A7C-223E792581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30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02436" rtl="0" eaLnBrk="1" latinLnBrk="0" hangingPunct="1">
        <a:lnSpc>
          <a:spcPct val="90000"/>
        </a:lnSpc>
        <a:spcBef>
          <a:spcPct val="0"/>
        </a:spcBef>
        <a:buNone/>
        <a:defRPr kumimoji="1" sz="57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0609" indent="-300609" algn="l" defTabSz="1202436" rtl="0" eaLnBrk="1" latinLnBrk="0" hangingPunct="1">
        <a:lnSpc>
          <a:spcPct val="90000"/>
        </a:lnSpc>
        <a:spcBef>
          <a:spcPts val="1315"/>
        </a:spcBef>
        <a:buFont typeface="Arial" panose="020B0604020202020204" pitchFamily="34" charset="0"/>
        <a:buChar char="•"/>
        <a:defRPr kumimoji="1" sz="3682" kern="1200">
          <a:solidFill>
            <a:schemeClr val="tx1"/>
          </a:solidFill>
          <a:latin typeface="+mn-lt"/>
          <a:ea typeface="+mn-ea"/>
          <a:cs typeface="+mn-cs"/>
        </a:defRPr>
      </a:lvl1pPr>
      <a:lvl2pPr marL="90182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3156" kern="1200">
          <a:solidFill>
            <a:schemeClr val="tx1"/>
          </a:solidFill>
          <a:latin typeface="+mn-lt"/>
          <a:ea typeface="+mn-ea"/>
          <a:cs typeface="+mn-cs"/>
        </a:defRPr>
      </a:lvl2pPr>
      <a:lvl3pPr marL="150304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630" kern="1200">
          <a:solidFill>
            <a:schemeClr val="tx1"/>
          </a:solidFill>
          <a:latin typeface="+mn-lt"/>
          <a:ea typeface="+mn-ea"/>
          <a:cs typeface="+mn-cs"/>
        </a:defRPr>
      </a:lvl3pPr>
      <a:lvl4pPr marL="210426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705481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306699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90791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50913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511035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1pPr>
      <a:lvl2pPr marL="601218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2pPr>
      <a:lvl3pPr marL="1202436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3pPr>
      <a:lvl4pPr marL="1803654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404872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006090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607308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208526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4809744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8C9822B-CFE5-ED4D-C4E2-B2592D3B7855}"/>
              </a:ext>
            </a:extLst>
          </p:cNvPr>
          <p:cNvSpPr txBox="1"/>
          <p:nvPr/>
        </p:nvSpPr>
        <p:spPr>
          <a:xfrm>
            <a:off x="425668" y="976973"/>
            <a:ext cx="3324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.  Histology (non-CC/MC vs. CC/MC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7CF3C1-4F01-EC1A-C6C3-62BC5F2F1AE2}"/>
              </a:ext>
            </a:extLst>
          </p:cNvPr>
          <p:cNvSpPr txBox="1"/>
          <p:nvPr/>
        </p:nvSpPr>
        <p:spPr>
          <a:xfrm>
            <a:off x="109707" y="162320"/>
            <a:ext cx="9697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plan-Meier estimates of the time to treatment failure according to each factor</a:t>
            </a:r>
            <a:endParaRPr kumimoji="1" lang="en-US" altLang="ja-JP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65EF92A-6B8B-26B5-B1DB-EE97ADB23BB1}"/>
              </a:ext>
            </a:extLst>
          </p:cNvPr>
          <p:cNvSpPr txBox="1"/>
          <p:nvPr/>
        </p:nvSpPr>
        <p:spPr>
          <a:xfrm>
            <a:off x="8097355" y="974791"/>
            <a:ext cx="4094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. Treatment line (1st line vs. 2nd or later line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67B539F-E3C9-D646-E63A-9651DB01C1BE}"/>
              </a:ext>
            </a:extLst>
          </p:cNvPr>
          <p:cNvSpPr txBox="1"/>
          <p:nvPr/>
        </p:nvSpPr>
        <p:spPr>
          <a:xfrm>
            <a:off x="4406630" y="4362762"/>
            <a:ext cx="3038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. Ascites (absence vs. presence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DB8871C-3A7D-DC53-8691-B28A135E0CB8}"/>
              </a:ext>
            </a:extLst>
          </p:cNvPr>
          <p:cNvSpPr txBox="1"/>
          <p:nvPr/>
        </p:nvSpPr>
        <p:spPr>
          <a:xfrm>
            <a:off x="425668" y="7620899"/>
            <a:ext cx="1131735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plan-Meier curve</a:t>
            </a:r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the time to treatment failure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ccording</a:t>
            </a:r>
            <a:r>
              <a:rPr lang="ja-JP" altLang="en-US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</a:t>
            </a:r>
            <a:r>
              <a:rPr lang="ja-JP" altLang="en-US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</a:t>
            </a:r>
            <a:r>
              <a:rPr lang="ja-JP" altLang="en-US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actor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median time to treatment failure calculated by the Kaplan-Meier according to each factor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s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hown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fferences in 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TF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between each factor were evaluated with the log-rank test. </a:t>
            </a:r>
            <a:endParaRPr lang="en-US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TTF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edian time to treatment failure; CI, confidence interval; CC, 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lear cell carcinoma; MC, mucinous carcinoma; Bev, bevacizumab; 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1D5AD39F-68D4-4535-2D61-2B1B76ED5F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430" y="1324629"/>
            <a:ext cx="2944001" cy="288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A6D3B18F-62BE-5EFC-44A4-2C2E48637C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34589" y="1292728"/>
            <a:ext cx="2944001" cy="28800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0372B8F-0B7C-ED9B-1BF2-46C7537CB635}"/>
              </a:ext>
            </a:extLst>
          </p:cNvPr>
          <p:cNvSpPr txBox="1"/>
          <p:nvPr/>
        </p:nvSpPr>
        <p:spPr>
          <a:xfrm>
            <a:off x="3983446" y="974791"/>
            <a:ext cx="403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. Platinum-free interval (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 Mos vs. &lt; 3 Mos)</a:t>
            </a: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F6390266-3C60-3DB6-933D-061B722C9C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6630" y="1313049"/>
            <a:ext cx="2944001" cy="288000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5E4A23E-9B8C-F540-6C3B-FDCC53E9DFC8}"/>
              </a:ext>
            </a:extLst>
          </p:cNvPr>
          <p:cNvSpPr txBox="1"/>
          <p:nvPr/>
        </p:nvSpPr>
        <p:spPr>
          <a:xfrm>
            <a:off x="425668" y="4356496"/>
            <a:ext cx="38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evcizumab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(with Bev vs. without Bev)</a:t>
            </a: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922281FF-A9A6-7231-6DCE-C4EBC4E0D2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9950" y="4705719"/>
            <a:ext cx="2944001" cy="288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1EE86F74-7BA7-39CD-9787-F98CED23CBC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06629" y="4710418"/>
            <a:ext cx="2944001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0181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7CF3C1-4F01-EC1A-C6C3-62BC5F2F1AE2}"/>
              </a:ext>
            </a:extLst>
          </p:cNvPr>
          <p:cNvSpPr txBox="1"/>
          <p:nvPr/>
        </p:nvSpPr>
        <p:spPr>
          <a:xfrm>
            <a:off x="597387" y="337321"/>
            <a:ext cx="8146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orest plot of the time to treatment failure according to ascit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DB8871C-3A7D-DC53-8691-B28A135E0CB8}"/>
              </a:ext>
            </a:extLst>
          </p:cNvPr>
          <p:cNvSpPr txBox="1"/>
          <p:nvPr/>
        </p:nvSpPr>
        <p:spPr>
          <a:xfrm>
            <a:off x="437321" y="5805821"/>
            <a:ext cx="11317357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orest plot of the time to treatment failure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ccording</a:t>
            </a:r>
            <a:r>
              <a:rPr lang="ja-JP" altLang="en-US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</a:t>
            </a:r>
            <a:r>
              <a:rPr lang="ja-JP" altLang="en-US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scites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median time to treatment failure (TTF) calculated by the Kaplan-Meier and the hazard ratio (HR) calculated by the univariate Cox proportional hazard model of each cytotoxic chemotherapy are shown. </a:t>
            </a:r>
            <a:endParaRPr lang="en-US" altLang="ja-JP" sz="1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TF, time to treatment failure; CPT-11, irinotecan; GEM, gemcitabine; PLD, pegylated liposomal doxorubicin; NDP, nedaplatin; HR, hazard ratio; CI, confidence interval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B43316EA-7755-D2EF-8023-5C979196DC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050" y="1015232"/>
            <a:ext cx="8525732" cy="45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694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279EBAE-1FED-6483-9AE1-91661968CE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784" y="1463250"/>
            <a:ext cx="4798307" cy="36000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A97FD55-9EBE-EA7C-06F2-4A8A2FD7AB82}"/>
              </a:ext>
            </a:extLst>
          </p:cNvPr>
          <p:cNvSpPr txBox="1"/>
          <p:nvPr/>
        </p:nvSpPr>
        <p:spPr>
          <a:xfrm>
            <a:off x="615940" y="990053"/>
            <a:ext cx="363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. Interstitial pneumonia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45B99EF-90D2-E8E9-3626-9436D9B7B78C}"/>
              </a:ext>
            </a:extLst>
          </p:cNvPr>
          <p:cNvSpPr txBox="1"/>
          <p:nvPr/>
        </p:nvSpPr>
        <p:spPr>
          <a:xfrm>
            <a:off x="6261809" y="990052"/>
            <a:ext cx="363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. Thromboembolic event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271E9B5-B5FF-4244-3696-FB77F2FFE04F}"/>
              </a:ext>
            </a:extLst>
          </p:cNvPr>
          <p:cNvSpPr txBox="1"/>
          <p:nvPr/>
        </p:nvSpPr>
        <p:spPr>
          <a:xfrm>
            <a:off x="295237" y="206948"/>
            <a:ext cx="50794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S3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Timing of adverse events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B80B6A23-71DC-D4C1-A6C9-5AB0106884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463250"/>
            <a:ext cx="4798307" cy="360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BC80D61-ACBC-DEFB-99DC-5DFAB4269C09}"/>
              </a:ext>
            </a:extLst>
          </p:cNvPr>
          <p:cNvSpPr txBox="1"/>
          <p:nvPr/>
        </p:nvSpPr>
        <p:spPr>
          <a:xfrm>
            <a:off x="715617" y="5725838"/>
            <a:ext cx="11039061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ing of adverse events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timing of adverse events was summarized.</a:t>
            </a:r>
          </a:p>
          <a:p>
            <a:pPr algn="just"/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 Interstitial pneumonia and (b)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hromboembolic events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PT-11, irinotecan; GEM, gemcitabine; PLD, pegylated liposomal doxorubicin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8201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0</TotalTime>
  <Words>292</Words>
  <Application>Microsoft Office PowerPoint</Application>
  <PresentationFormat>ユーザー設定</PresentationFormat>
  <Paragraphs>2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口 歩</dc:creator>
  <cp:lastModifiedBy>歩 田口</cp:lastModifiedBy>
  <cp:revision>45</cp:revision>
  <dcterms:created xsi:type="dcterms:W3CDTF">2022-10-02T09:35:59Z</dcterms:created>
  <dcterms:modified xsi:type="dcterms:W3CDTF">2023-05-14T03:21:34Z</dcterms:modified>
</cp:coreProperties>
</file>